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6"/>
  </p:notesMasterIdLst>
  <p:sldIdLst>
    <p:sldId id="312" r:id="rId5"/>
  </p:sldIdLst>
  <p:sldSz cx="6858000" cy="9906000" type="A4"/>
  <p:notesSz cx="7315200" cy="96012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33CC"/>
    <a:srgbClr val="CC9900"/>
    <a:srgbClr val="FFCC00"/>
    <a:srgbClr val="FFFFFF"/>
    <a:srgbClr val="E8B7B7"/>
    <a:srgbClr val="A8CDD7"/>
    <a:srgbClr val="FF5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5161" autoAdjust="0"/>
  </p:normalViewPr>
  <p:slideViewPr>
    <p:cSldViewPr snapToGrid="0">
      <p:cViewPr varScale="1">
        <p:scale>
          <a:sx n="71" d="100"/>
          <a:sy n="71" d="100"/>
        </p:scale>
        <p:origin x="84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ra Weis" userId="6a51f4e6-0e93-4a18-834c-a49e1ed77407" providerId="ADAL" clId="{6959E033-7E6A-4EA0-AB19-75F676599088}"/>
    <pc:docChg chg="undo custSel addSld delSld modSld">
      <pc:chgData name="Sara Weis" userId="6a51f4e6-0e93-4a18-834c-a49e1ed77407" providerId="ADAL" clId="{6959E033-7E6A-4EA0-AB19-75F676599088}" dt="2025-01-02T17:23:24.763" v="425" actId="2696"/>
      <pc:docMkLst>
        <pc:docMk/>
      </pc:docMkLst>
      <pc:sldChg chg="addSp delSp modSp del">
        <pc:chgData name="Sara Weis" userId="6a51f4e6-0e93-4a18-834c-a49e1ed77407" providerId="ADAL" clId="{6959E033-7E6A-4EA0-AB19-75F676599088}" dt="2025-01-02T17:23:24.753" v="423" actId="2696"/>
        <pc:sldMkLst>
          <pc:docMk/>
          <pc:sldMk cId="2106248321" sldId="298"/>
        </pc:sldMkLst>
        <pc:spChg chg="add mod">
          <ac:chgData name="Sara Weis" userId="6a51f4e6-0e93-4a18-834c-a49e1ed77407" providerId="ADAL" clId="{6959E033-7E6A-4EA0-AB19-75F676599088}" dt="2025-01-02T17:15:24.765" v="382" actId="20577"/>
          <ac:spMkLst>
            <pc:docMk/>
            <pc:sldMk cId="2106248321" sldId="298"/>
            <ac:spMk id="3" creationId="{F85F01AF-E2FC-4A20-BC96-820C3267DBD5}"/>
          </ac:spMkLst>
        </pc:spChg>
        <pc:spChg chg="mod">
          <ac:chgData name="Sara Weis" userId="6a51f4e6-0e93-4a18-834c-a49e1ed77407" providerId="ADAL" clId="{6959E033-7E6A-4EA0-AB19-75F676599088}" dt="2025-01-02T16:56:55.861" v="67" actId="122"/>
          <ac:spMkLst>
            <pc:docMk/>
            <pc:sldMk cId="2106248321" sldId="298"/>
            <ac:spMk id="9" creationId="{75936999-04B7-4CA0-96C9-CD97C06BD1F1}"/>
          </ac:spMkLst>
        </pc:spChg>
        <pc:spChg chg="mod">
          <ac:chgData name="Sara Weis" userId="6a51f4e6-0e93-4a18-834c-a49e1ed77407" providerId="ADAL" clId="{6959E033-7E6A-4EA0-AB19-75F676599088}" dt="2025-01-02T16:56:55.861" v="67" actId="122"/>
          <ac:spMkLst>
            <pc:docMk/>
            <pc:sldMk cId="2106248321" sldId="298"/>
            <ac:spMk id="10" creationId="{98561D18-56B5-4A22-B657-19C0C43B029A}"/>
          </ac:spMkLst>
        </pc:spChg>
        <pc:spChg chg="mod">
          <ac:chgData name="Sara Weis" userId="6a51f4e6-0e93-4a18-834c-a49e1ed77407" providerId="ADAL" clId="{6959E033-7E6A-4EA0-AB19-75F676599088}" dt="2025-01-02T16:56:55.861" v="67" actId="122"/>
          <ac:spMkLst>
            <pc:docMk/>
            <pc:sldMk cId="2106248321" sldId="298"/>
            <ac:spMk id="11" creationId="{06F6387F-5DC2-44EE-B710-A3F4811AD05E}"/>
          </ac:spMkLst>
        </pc:spChg>
        <pc:spChg chg="mod">
          <ac:chgData name="Sara Weis" userId="6a51f4e6-0e93-4a18-834c-a49e1ed77407" providerId="ADAL" clId="{6959E033-7E6A-4EA0-AB19-75F676599088}" dt="2025-01-02T16:56:55.861" v="67" actId="122"/>
          <ac:spMkLst>
            <pc:docMk/>
            <pc:sldMk cId="2106248321" sldId="298"/>
            <ac:spMk id="12" creationId="{B599E299-20AD-4B90-863E-C9F21A3FC407}"/>
          </ac:spMkLst>
        </pc:spChg>
        <pc:spChg chg="mod">
          <ac:chgData name="Sara Weis" userId="6a51f4e6-0e93-4a18-834c-a49e1ed77407" providerId="ADAL" clId="{6959E033-7E6A-4EA0-AB19-75F676599088}" dt="2025-01-02T16:56:55.861" v="67" actId="122"/>
          <ac:spMkLst>
            <pc:docMk/>
            <pc:sldMk cId="2106248321" sldId="298"/>
            <ac:spMk id="19" creationId="{236DD729-0233-4845-B1E1-FF2549A9C872}"/>
          </ac:spMkLst>
        </pc:spChg>
        <pc:spChg chg="mod">
          <ac:chgData name="Sara Weis" userId="6a51f4e6-0e93-4a18-834c-a49e1ed77407" providerId="ADAL" clId="{6959E033-7E6A-4EA0-AB19-75F676599088}" dt="2025-01-02T16:56:55.861" v="67" actId="122"/>
          <ac:spMkLst>
            <pc:docMk/>
            <pc:sldMk cId="2106248321" sldId="298"/>
            <ac:spMk id="20" creationId="{87F2151C-91AE-444F-BA0A-F5DE6A8495AA}"/>
          </ac:spMkLst>
        </pc:spChg>
        <pc:spChg chg="mod">
          <ac:chgData name="Sara Weis" userId="6a51f4e6-0e93-4a18-834c-a49e1ed77407" providerId="ADAL" clId="{6959E033-7E6A-4EA0-AB19-75F676599088}" dt="2025-01-02T17:08:03.483" v="375" actId="1076"/>
          <ac:spMkLst>
            <pc:docMk/>
            <pc:sldMk cId="2106248321" sldId="298"/>
            <ac:spMk id="23" creationId="{9837469B-6902-495A-86E3-722D7C6A57DC}"/>
          </ac:spMkLst>
        </pc:spChg>
        <pc:spChg chg="del">
          <ac:chgData name="Sara Weis" userId="6a51f4e6-0e93-4a18-834c-a49e1ed77407" providerId="ADAL" clId="{6959E033-7E6A-4EA0-AB19-75F676599088}" dt="2025-01-02T17:05:57.477" v="359" actId="478"/>
          <ac:spMkLst>
            <pc:docMk/>
            <pc:sldMk cId="2106248321" sldId="298"/>
            <ac:spMk id="45" creationId="{F3A9156C-C54C-4614-ABB9-5AF095F0F775}"/>
          </ac:spMkLst>
        </pc:spChg>
        <pc:spChg chg="mod">
          <ac:chgData name="Sara Weis" userId="6a51f4e6-0e93-4a18-834c-a49e1ed77407" providerId="ADAL" clId="{6959E033-7E6A-4EA0-AB19-75F676599088}" dt="2025-01-02T16:57:01.182" v="68" actId="1076"/>
          <ac:spMkLst>
            <pc:docMk/>
            <pc:sldMk cId="2106248321" sldId="298"/>
            <ac:spMk id="56" creationId="{1CE285CC-DC0D-4825-9EDF-E3D5D8427719}"/>
          </ac:spMkLst>
        </pc:spChg>
        <pc:spChg chg="mod">
          <ac:chgData name="Sara Weis" userId="6a51f4e6-0e93-4a18-834c-a49e1ed77407" providerId="ADAL" clId="{6959E033-7E6A-4EA0-AB19-75F676599088}" dt="2025-01-02T17:08:03.483" v="375" actId="1076"/>
          <ac:spMkLst>
            <pc:docMk/>
            <pc:sldMk cId="2106248321" sldId="298"/>
            <ac:spMk id="70" creationId="{7A30D47F-4FE9-4840-9977-6022DD4A371A}"/>
          </ac:spMkLst>
        </pc:spChg>
        <pc:spChg chg="mod">
          <ac:chgData name="Sara Weis" userId="6a51f4e6-0e93-4a18-834c-a49e1ed77407" providerId="ADAL" clId="{6959E033-7E6A-4EA0-AB19-75F676599088}" dt="2025-01-02T16:56:55.861" v="67" actId="122"/>
          <ac:spMkLst>
            <pc:docMk/>
            <pc:sldMk cId="2106248321" sldId="298"/>
            <ac:spMk id="76" creationId="{3F6D0F30-184D-40C5-AF9D-82030B65FD09}"/>
          </ac:spMkLst>
        </pc:spChg>
        <pc:spChg chg="mod">
          <ac:chgData name="Sara Weis" userId="6a51f4e6-0e93-4a18-834c-a49e1ed77407" providerId="ADAL" clId="{6959E033-7E6A-4EA0-AB19-75F676599088}" dt="2025-01-02T16:56:55.861" v="67" actId="122"/>
          <ac:spMkLst>
            <pc:docMk/>
            <pc:sldMk cId="2106248321" sldId="298"/>
            <ac:spMk id="77" creationId="{8CB2C145-4003-477F-81BA-EEA2846A0D4F}"/>
          </ac:spMkLst>
        </pc:spChg>
        <pc:spChg chg="mod">
          <ac:chgData name="Sara Weis" userId="6a51f4e6-0e93-4a18-834c-a49e1ed77407" providerId="ADAL" clId="{6959E033-7E6A-4EA0-AB19-75F676599088}" dt="2025-01-02T16:56:55.861" v="67" actId="122"/>
          <ac:spMkLst>
            <pc:docMk/>
            <pc:sldMk cId="2106248321" sldId="298"/>
            <ac:spMk id="78" creationId="{5B67D640-44A5-4C40-8143-D52616D97BD9}"/>
          </ac:spMkLst>
        </pc:spChg>
        <pc:spChg chg="mod">
          <ac:chgData name="Sara Weis" userId="6a51f4e6-0e93-4a18-834c-a49e1ed77407" providerId="ADAL" clId="{6959E033-7E6A-4EA0-AB19-75F676599088}" dt="2025-01-02T16:56:55.861" v="67" actId="122"/>
          <ac:spMkLst>
            <pc:docMk/>
            <pc:sldMk cId="2106248321" sldId="298"/>
            <ac:spMk id="84" creationId="{B5744F81-4DF0-4530-87BD-B543F756DD8F}"/>
          </ac:spMkLst>
        </pc:spChg>
        <pc:spChg chg="mod">
          <ac:chgData name="Sara Weis" userId="6a51f4e6-0e93-4a18-834c-a49e1ed77407" providerId="ADAL" clId="{6959E033-7E6A-4EA0-AB19-75F676599088}" dt="2025-01-02T16:56:55.861" v="67" actId="122"/>
          <ac:spMkLst>
            <pc:docMk/>
            <pc:sldMk cId="2106248321" sldId="298"/>
            <ac:spMk id="85" creationId="{D04BE4A0-467D-4070-B64B-9F2C118EF847}"/>
          </ac:spMkLst>
        </pc:spChg>
        <pc:spChg chg="mod">
          <ac:chgData name="Sara Weis" userId="6a51f4e6-0e93-4a18-834c-a49e1ed77407" providerId="ADAL" clId="{6959E033-7E6A-4EA0-AB19-75F676599088}" dt="2025-01-02T16:56:55.861" v="67" actId="122"/>
          <ac:spMkLst>
            <pc:docMk/>
            <pc:sldMk cId="2106248321" sldId="298"/>
            <ac:spMk id="86" creationId="{98515101-AB5F-4E78-A682-FFAEA0B99110}"/>
          </ac:spMkLst>
        </pc:spChg>
        <pc:spChg chg="mod">
          <ac:chgData name="Sara Weis" userId="6a51f4e6-0e93-4a18-834c-a49e1ed77407" providerId="ADAL" clId="{6959E033-7E6A-4EA0-AB19-75F676599088}" dt="2025-01-02T16:56:55.861" v="67" actId="122"/>
          <ac:spMkLst>
            <pc:docMk/>
            <pc:sldMk cId="2106248321" sldId="298"/>
            <ac:spMk id="88" creationId="{5C118BE6-EAB6-49A0-8589-3C1535D4CA55}"/>
          </ac:spMkLst>
        </pc:spChg>
        <pc:spChg chg="mod">
          <ac:chgData name="Sara Weis" userId="6a51f4e6-0e93-4a18-834c-a49e1ed77407" providerId="ADAL" clId="{6959E033-7E6A-4EA0-AB19-75F676599088}" dt="2025-01-02T16:57:10.910" v="87" actId="1035"/>
          <ac:spMkLst>
            <pc:docMk/>
            <pc:sldMk cId="2106248321" sldId="298"/>
            <ac:spMk id="94" creationId="{2650BDE5-AD2F-42F9-A372-1968EC006B7E}"/>
          </ac:spMkLst>
        </pc:spChg>
        <pc:grpChg chg="add mod">
          <ac:chgData name="Sara Weis" userId="6a51f4e6-0e93-4a18-834c-a49e1ed77407" providerId="ADAL" clId="{6959E033-7E6A-4EA0-AB19-75F676599088}" dt="2025-01-02T17:08:09.193" v="377" actId="14100"/>
          <ac:grpSpMkLst>
            <pc:docMk/>
            <pc:sldMk cId="2106248321" sldId="298"/>
            <ac:grpSpMk id="2" creationId="{960064E3-9BEA-4925-8610-BCA826CE0C41}"/>
          </ac:grpSpMkLst>
        </pc:grpChg>
        <pc:grpChg chg="mod">
          <ac:chgData name="Sara Weis" userId="6a51f4e6-0e93-4a18-834c-a49e1ed77407" providerId="ADAL" clId="{6959E033-7E6A-4EA0-AB19-75F676599088}" dt="2025-01-02T16:56:35.670" v="63" actId="164"/>
          <ac:grpSpMkLst>
            <pc:docMk/>
            <pc:sldMk cId="2106248321" sldId="298"/>
            <ac:grpSpMk id="18" creationId="{6C3C0227-C401-42B7-83D7-5BCA28C7679E}"/>
          </ac:grpSpMkLst>
        </pc:grpChg>
        <pc:grpChg chg="mod">
          <ac:chgData name="Sara Weis" userId="6a51f4e6-0e93-4a18-834c-a49e1ed77407" providerId="ADAL" clId="{6959E033-7E6A-4EA0-AB19-75F676599088}" dt="2025-01-02T16:56:35.670" v="63" actId="164"/>
          <ac:grpSpMkLst>
            <pc:docMk/>
            <pc:sldMk cId="2106248321" sldId="298"/>
            <ac:grpSpMk id="24" creationId="{D5F64F85-735E-4924-B238-3BB390ADA6D2}"/>
          </ac:grpSpMkLst>
        </pc:grpChg>
        <pc:cxnChg chg="mod">
          <ac:chgData name="Sara Weis" userId="6a51f4e6-0e93-4a18-834c-a49e1ed77407" providerId="ADAL" clId="{6959E033-7E6A-4EA0-AB19-75F676599088}" dt="2025-01-02T16:56:35.670" v="63" actId="164"/>
          <ac:cxnSpMkLst>
            <pc:docMk/>
            <pc:sldMk cId="2106248321" sldId="298"/>
            <ac:cxnSpMk id="55" creationId="{444086A9-B7E4-41B3-B776-3280FA8A5349}"/>
          </ac:cxnSpMkLst>
        </pc:cxnChg>
        <pc:cxnChg chg="mod">
          <ac:chgData name="Sara Weis" userId="6a51f4e6-0e93-4a18-834c-a49e1ed77407" providerId="ADAL" clId="{6959E033-7E6A-4EA0-AB19-75F676599088}" dt="2025-01-02T16:57:10.910" v="87" actId="1035"/>
          <ac:cxnSpMkLst>
            <pc:docMk/>
            <pc:sldMk cId="2106248321" sldId="298"/>
            <ac:cxnSpMk id="93" creationId="{DBB2319C-3D95-4D00-AFE1-D23979B8E566}"/>
          </ac:cxnSpMkLst>
        </pc:cxnChg>
      </pc:sldChg>
      <pc:sldChg chg="addSp delSp modSp del">
        <pc:chgData name="Sara Weis" userId="6a51f4e6-0e93-4a18-834c-a49e1ed77407" providerId="ADAL" clId="{6959E033-7E6A-4EA0-AB19-75F676599088}" dt="2025-01-02T17:23:24.756" v="424" actId="2696"/>
        <pc:sldMkLst>
          <pc:docMk/>
          <pc:sldMk cId="1407140874" sldId="309"/>
        </pc:sldMkLst>
        <pc:spChg chg="add mod">
          <ac:chgData name="Sara Weis" userId="6a51f4e6-0e93-4a18-834c-a49e1ed77407" providerId="ADAL" clId="{6959E033-7E6A-4EA0-AB19-75F676599088}" dt="2025-01-02T17:16:14.495" v="386" actId="403"/>
          <ac:spMkLst>
            <pc:docMk/>
            <pc:sldMk cId="1407140874" sldId="309"/>
            <ac:spMk id="3" creationId="{442AB1F2-5941-4F44-AC8D-E4A87AD7535C}"/>
          </ac:spMkLst>
        </pc:spChg>
        <pc:spChg chg="del">
          <ac:chgData name="Sara Weis" userId="6a51f4e6-0e93-4a18-834c-a49e1ed77407" providerId="ADAL" clId="{6959E033-7E6A-4EA0-AB19-75F676599088}" dt="2025-01-02T16:58:07.845" v="111" actId="478"/>
          <ac:spMkLst>
            <pc:docMk/>
            <pc:sldMk cId="1407140874" sldId="309"/>
            <ac:spMk id="5" creationId="{B847A6B5-FE3F-456F-A592-96E2D8DDCCD8}"/>
          </ac:spMkLst>
        </pc:spChg>
        <pc:spChg chg="mod topLvl">
          <ac:chgData name="Sara Weis" userId="6a51f4e6-0e93-4a18-834c-a49e1ed77407" providerId="ADAL" clId="{6959E033-7E6A-4EA0-AB19-75F676599088}" dt="2025-01-02T17:00:26.168" v="180" actId="164"/>
          <ac:spMkLst>
            <pc:docMk/>
            <pc:sldMk cId="1407140874" sldId="309"/>
            <ac:spMk id="7" creationId="{65344804-014D-4F7F-89BE-8FDBDC89E59A}"/>
          </ac:spMkLst>
        </pc:spChg>
        <pc:spChg chg="mod topLvl">
          <ac:chgData name="Sara Weis" userId="6a51f4e6-0e93-4a18-834c-a49e1ed77407" providerId="ADAL" clId="{6959E033-7E6A-4EA0-AB19-75F676599088}" dt="2025-01-02T17:00:26.168" v="180" actId="164"/>
          <ac:spMkLst>
            <pc:docMk/>
            <pc:sldMk cId="1407140874" sldId="309"/>
            <ac:spMk id="8" creationId="{08887007-58A9-4043-A9A2-D0CC96D1F9D6}"/>
          </ac:spMkLst>
        </pc:spChg>
        <pc:spChg chg="mod topLvl">
          <ac:chgData name="Sara Weis" userId="6a51f4e6-0e93-4a18-834c-a49e1ed77407" providerId="ADAL" clId="{6959E033-7E6A-4EA0-AB19-75F676599088}" dt="2025-01-02T17:18:41.401" v="421" actId="1076"/>
          <ac:spMkLst>
            <pc:docMk/>
            <pc:sldMk cId="1407140874" sldId="309"/>
            <ac:spMk id="20" creationId="{6881229C-7153-4EB2-8DAA-13FD4A567142}"/>
          </ac:spMkLst>
        </pc:spChg>
        <pc:spChg chg="mod topLvl">
          <ac:chgData name="Sara Weis" userId="6a51f4e6-0e93-4a18-834c-a49e1ed77407" providerId="ADAL" clId="{6959E033-7E6A-4EA0-AB19-75F676599088}" dt="2025-01-02T17:00:26.168" v="180" actId="164"/>
          <ac:spMkLst>
            <pc:docMk/>
            <pc:sldMk cId="1407140874" sldId="309"/>
            <ac:spMk id="25" creationId="{1739EE7F-4B26-492C-9A21-D8B4D53A95D3}"/>
          </ac:spMkLst>
        </pc:spChg>
        <pc:spChg chg="mod topLvl">
          <ac:chgData name="Sara Weis" userId="6a51f4e6-0e93-4a18-834c-a49e1ed77407" providerId="ADAL" clId="{6959E033-7E6A-4EA0-AB19-75F676599088}" dt="2025-01-02T17:00:26.168" v="180" actId="164"/>
          <ac:spMkLst>
            <pc:docMk/>
            <pc:sldMk cId="1407140874" sldId="309"/>
            <ac:spMk id="26" creationId="{9F8B62C0-0701-4452-9ECE-E70CF3460A27}"/>
          </ac:spMkLst>
        </pc:spChg>
        <pc:spChg chg="mod topLvl">
          <ac:chgData name="Sara Weis" userId="6a51f4e6-0e93-4a18-834c-a49e1ed77407" providerId="ADAL" clId="{6959E033-7E6A-4EA0-AB19-75F676599088}" dt="2025-01-02T17:18:41.401" v="421" actId="1076"/>
          <ac:spMkLst>
            <pc:docMk/>
            <pc:sldMk cId="1407140874" sldId="309"/>
            <ac:spMk id="27" creationId="{AFD89C10-828B-4348-9400-D3F10865C33A}"/>
          </ac:spMkLst>
        </pc:spChg>
        <pc:spChg chg="mod topLvl">
          <ac:chgData name="Sara Weis" userId="6a51f4e6-0e93-4a18-834c-a49e1ed77407" providerId="ADAL" clId="{6959E033-7E6A-4EA0-AB19-75F676599088}" dt="2025-01-02T17:18:41.401" v="421" actId="1076"/>
          <ac:spMkLst>
            <pc:docMk/>
            <pc:sldMk cId="1407140874" sldId="309"/>
            <ac:spMk id="29" creationId="{96BDDBF5-E0E9-4EDD-8442-02BF3C3A13F5}"/>
          </ac:spMkLst>
        </pc:spChg>
        <pc:spChg chg="mod topLvl">
          <ac:chgData name="Sara Weis" userId="6a51f4e6-0e93-4a18-834c-a49e1ed77407" providerId="ADAL" clId="{6959E033-7E6A-4EA0-AB19-75F676599088}" dt="2025-01-02T17:00:26.168" v="180" actId="164"/>
          <ac:spMkLst>
            <pc:docMk/>
            <pc:sldMk cId="1407140874" sldId="309"/>
            <ac:spMk id="31" creationId="{7D00C1B0-C791-429C-AD61-4475D35B2BB9}"/>
          </ac:spMkLst>
        </pc:spChg>
        <pc:spChg chg="mod topLvl">
          <ac:chgData name="Sara Weis" userId="6a51f4e6-0e93-4a18-834c-a49e1ed77407" providerId="ADAL" clId="{6959E033-7E6A-4EA0-AB19-75F676599088}" dt="2025-01-02T17:00:26.168" v="180" actId="164"/>
          <ac:spMkLst>
            <pc:docMk/>
            <pc:sldMk cId="1407140874" sldId="309"/>
            <ac:spMk id="32" creationId="{4B4C88B7-534D-4392-8B45-CD4DBD0E06DC}"/>
          </ac:spMkLst>
        </pc:spChg>
        <pc:spChg chg="add del mod">
          <ac:chgData name="Sara Weis" userId="6a51f4e6-0e93-4a18-834c-a49e1ed77407" providerId="ADAL" clId="{6959E033-7E6A-4EA0-AB19-75F676599088}" dt="2025-01-02T17:05:36.901" v="355" actId="478"/>
          <ac:spMkLst>
            <pc:docMk/>
            <pc:sldMk cId="1407140874" sldId="309"/>
            <ac:spMk id="36" creationId="{146899AB-8D1C-4F16-8820-601965BA1003}"/>
          </ac:spMkLst>
        </pc:spChg>
        <pc:spChg chg="mod topLvl">
          <ac:chgData name="Sara Weis" userId="6a51f4e6-0e93-4a18-834c-a49e1ed77407" providerId="ADAL" clId="{6959E033-7E6A-4EA0-AB19-75F676599088}" dt="2025-01-02T17:00:26.168" v="180" actId="164"/>
          <ac:spMkLst>
            <pc:docMk/>
            <pc:sldMk cId="1407140874" sldId="309"/>
            <ac:spMk id="62" creationId="{108CAF4E-2AB6-4B17-9E6F-F1E346041C65}"/>
          </ac:spMkLst>
        </pc:spChg>
        <pc:spChg chg="mod topLvl">
          <ac:chgData name="Sara Weis" userId="6a51f4e6-0e93-4a18-834c-a49e1ed77407" providerId="ADAL" clId="{6959E033-7E6A-4EA0-AB19-75F676599088}" dt="2025-01-02T17:00:26.168" v="180" actId="164"/>
          <ac:spMkLst>
            <pc:docMk/>
            <pc:sldMk cId="1407140874" sldId="309"/>
            <ac:spMk id="63" creationId="{511BFF64-48D6-483A-8213-539471607A7B}"/>
          </ac:spMkLst>
        </pc:spChg>
        <pc:spChg chg="mod topLvl">
          <ac:chgData name="Sara Weis" userId="6a51f4e6-0e93-4a18-834c-a49e1ed77407" providerId="ADAL" clId="{6959E033-7E6A-4EA0-AB19-75F676599088}" dt="2025-01-02T17:00:26.168" v="180" actId="164"/>
          <ac:spMkLst>
            <pc:docMk/>
            <pc:sldMk cId="1407140874" sldId="309"/>
            <ac:spMk id="66" creationId="{B972A8FF-4AEE-45F4-8801-82D1725996E7}"/>
          </ac:spMkLst>
        </pc:spChg>
        <pc:spChg chg="mod topLvl">
          <ac:chgData name="Sara Weis" userId="6a51f4e6-0e93-4a18-834c-a49e1ed77407" providerId="ADAL" clId="{6959E033-7E6A-4EA0-AB19-75F676599088}" dt="2025-01-02T17:00:26.168" v="180" actId="164"/>
          <ac:spMkLst>
            <pc:docMk/>
            <pc:sldMk cId="1407140874" sldId="309"/>
            <ac:spMk id="69" creationId="{7818342E-B8CF-47E2-93C2-646CD55FFAA5}"/>
          </ac:spMkLst>
        </pc:spChg>
        <pc:spChg chg="mod topLvl">
          <ac:chgData name="Sara Weis" userId="6a51f4e6-0e93-4a18-834c-a49e1ed77407" providerId="ADAL" clId="{6959E033-7E6A-4EA0-AB19-75F676599088}" dt="2025-01-02T17:00:26.168" v="180" actId="164"/>
          <ac:spMkLst>
            <pc:docMk/>
            <pc:sldMk cId="1407140874" sldId="309"/>
            <ac:spMk id="71" creationId="{BAD48846-1FF2-41CD-B750-B8CF8ED157F2}"/>
          </ac:spMkLst>
        </pc:spChg>
        <pc:spChg chg="mod topLvl">
          <ac:chgData name="Sara Weis" userId="6a51f4e6-0e93-4a18-834c-a49e1ed77407" providerId="ADAL" clId="{6959E033-7E6A-4EA0-AB19-75F676599088}" dt="2025-01-02T17:00:26.168" v="180" actId="164"/>
          <ac:spMkLst>
            <pc:docMk/>
            <pc:sldMk cId="1407140874" sldId="309"/>
            <ac:spMk id="72" creationId="{0B7EA0DE-D9AC-44F8-A250-58B0B4C4310A}"/>
          </ac:spMkLst>
        </pc:spChg>
        <pc:grpChg chg="add del mod">
          <ac:chgData name="Sara Weis" userId="6a51f4e6-0e93-4a18-834c-a49e1ed77407" providerId="ADAL" clId="{6959E033-7E6A-4EA0-AB19-75F676599088}" dt="2025-01-02T16:59:03.173" v="126" actId="165"/>
          <ac:grpSpMkLst>
            <pc:docMk/>
            <pc:sldMk cId="1407140874" sldId="309"/>
            <ac:grpSpMk id="2" creationId="{9BD144CA-C724-4B0F-B95A-C3F7FD4A5043}"/>
          </ac:grpSpMkLst>
        </pc:grpChg>
        <pc:grpChg chg="add mod">
          <ac:chgData name="Sara Weis" userId="6a51f4e6-0e93-4a18-834c-a49e1ed77407" providerId="ADAL" clId="{6959E033-7E6A-4EA0-AB19-75F676599088}" dt="2025-01-02T17:18:45.578" v="422" actId="1076"/>
          <ac:grpSpMkLst>
            <pc:docMk/>
            <pc:sldMk cId="1407140874" sldId="309"/>
            <ac:grpSpMk id="4" creationId="{EF7220AD-9458-4B13-9101-12BFA96A1810}"/>
          </ac:grpSpMkLst>
        </pc:grpChg>
        <pc:grpChg chg="mod topLvl">
          <ac:chgData name="Sara Weis" userId="6a51f4e6-0e93-4a18-834c-a49e1ed77407" providerId="ADAL" clId="{6959E033-7E6A-4EA0-AB19-75F676599088}" dt="2025-01-02T17:00:26.168" v="180" actId="164"/>
          <ac:grpSpMkLst>
            <pc:docMk/>
            <pc:sldMk cId="1407140874" sldId="309"/>
            <ac:grpSpMk id="35" creationId="{056DD648-E1CF-4B28-A93C-9EA63B3183AD}"/>
          </ac:grpSpMkLst>
        </pc:grpChg>
        <pc:grpChg chg="del mod topLvl">
          <ac:chgData name="Sara Weis" userId="6a51f4e6-0e93-4a18-834c-a49e1ed77407" providerId="ADAL" clId="{6959E033-7E6A-4EA0-AB19-75F676599088}" dt="2025-01-02T16:59:38.932" v="151" actId="165"/>
          <ac:grpSpMkLst>
            <pc:docMk/>
            <pc:sldMk cId="1407140874" sldId="309"/>
            <ac:grpSpMk id="77" creationId="{D67AE77C-DCA4-4EA9-BF3B-04475E2533A4}"/>
          </ac:grpSpMkLst>
        </pc:grpChg>
        <pc:picChg chg="mod topLvl">
          <ac:chgData name="Sara Weis" userId="6a51f4e6-0e93-4a18-834c-a49e1ed77407" providerId="ADAL" clId="{6959E033-7E6A-4EA0-AB19-75F676599088}" dt="2025-01-02T17:00:26.168" v="180" actId="164"/>
          <ac:picMkLst>
            <pc:docMk/>
            <pc:sldMk cId="1407140874" sldId="309"/>
            <ac:picMk id="19" creationId="{27EEF4B6-3B61-44D0-85D1-A7E062BA449C}"/>
          </ac:picMkLst>
        </pc:picChg>
        <pc:picChg chg="mod topLvl">
          <ac:chgData name="Sara Weis" userId="6a51f4e6-0e93-4a18-834c-a49e1ed77407" providerId="ADAL" clId="{6959E033-7E6A-4EA0-AB19-75F676599088}" dt="2025-01-02T17:00:26.168" v="180" actId="164"/>
          <ac:picMkLst>
            <pc:docMk/>
            <pc:sldMk cId="1407140874" sldId="309"/>
            <ac:picMk id="21" creationId="{FD23F2EB-CD30-4B78-8347-E59C22718A82}"/>
          </ac:picMkLst>
        </pc:picChg>
        <pc:picChg chg="mod topLvl">
          <ac:chgData name="Sara Weis" userId="6a51f4e6-0e93-4a18-834c-a49e1ed77407" providerId="ADAL" clId="{6959E033-7E6A-4EA0-AB19-75F676599088}" dt="2025-01-02T17:00:26.168" v="180" actId="164"/>
          <ac:picMkLst>
            <pc:docMk/>
            <pc:sldMk cId="1407140874" sldId="309"/>
            <ac:picMk id="45" creationId="{E5BF901F-73B1-4866-B87E-A2921145A5D4}"/>
          </ac:picMkLst>
        </pc:picChg>
        <pc:picChg chg="mod topLvl">
          <ac:chgData name="Sara Weis" userId="6a51f4e6-0e93-4a18-834c-a49e1ed77407" providerId="ADAL" clId="{6959E033-7E6A-4EA0-AB19-75F676599088}" dt="2025-01-02T17:00:26.168" v="180" actId="164"/>
          <ac:picMkLst>
            <pc:docMk/>
            <pc:sldMk cId="1407140874" sldId="309"/>
            <ac:picMk id="46" creationId="{D63FE4B1-4A92-4060-97D4-2DCCFD5A0A57}"/>
          </ac:picMkLst>
        </pc:picChg>
        <pc:picChg chg="mod topLvl">
          <ac:chgData name="Sara Weis" userId="6a51f4e6-0e93-4a18-834c-a49e1ed77407" providerId="ADAL" clId="{6959E033-7E6A-4EA0-AB19-75F676599088}" dt="2025-01-02T17:00:26.168" v="180" actId="164"/>
          <ac:picMkLst>
            <pc:docMk/>
            <pc:sldMk cId="1407140874" sldId="309"/>
            <ac:picMk id="47" creationId="{CC3F405E-00F9-49AE-834F-8D02BC0DEDDB}"/>
          </ac:picMkLst>
        </pc:picChg>
        <pc:picChg chg="mod topLvl">
          <ac:chgData name="Sara Weis" userId="6a51f4e6-0e93-4a18-834c-a49e1ed77407" providerId="ADAL" clId="{6959E033-7E6A-4EA0-AB19-75F676599088}" dt="2025-01-02T17:00:26.168" v="180" actId="164"/>
          <ac:picMkLst>
            <pc:docMk/>
            <pc:sldMk cId="1407140874" sldId="309"/>
            <ac:picMk id="49" creationId="{D6E85C12-BFDD-4BEA-AEA9-8FB8BDDFA099}"/>
          </ac:picMkLst>
        </pc:picChg>
        <pc:picChg chg="mod topLvl">
          <ac:chgData name="Sara Weis" userId="6a51f4e6-0e93-4a18-834c-a49e1ed77407" providerId="ADAL" clId="{6959E033-7E6A-4EA0-AB19-75F676599088}" dt="2025-01-02T17:00:26.168" v="180" actId="164"/>
          <ac:picMkLst>
            <pc:docMk/>
            <pc:sldMk cId="1407140874" sldId="309"/>
            <ac:picMk id="54" creationId="{96DAD91F-5FD9-4B38-8EA7-D2D986C34E88}"/>
          </ac:picMkLst>
        </pc:picChg>
        <pc:picChg chg="mod topLvl">
          <ac:chgData name="Sara Weis" userId="6a51f4e6-0e93-4a18-834c-a49e1ed77407" providerId="ADAL" clId="{6959E033-7E6A-4EA0-AB19-75F676599088}" dt="2025-01-02T17:00:26.168" v="180" actId="164"/>
          <ac:picMkLst>
            <pc:docMk/>
            <pc:sldMk cId="1407140874" sldId="309"/>
            <ac:picMk id="58" creationId="{3AD79D2C-BE67-4737-BD89-A0AB15F9DDF5}"/>
          </ac:picMkLst>
        </pc:picChg>
        <pc:cxnChg chg="mod topLvl">
          <ac:chgData name="Sara Weis" userId="6a51f4e6-0e93-4a18-834c-a49e1ed77407" providerId="ADAL" clId="{6959E033-7E6A-4EA0-AB19-75F676599088}" dt="2025-01-02T17:00:26.168" v="180" actId="164"/>
          <ac:cxnSpMkLst>
            <pc:docMk/>
            <pc:sldMk cId="1407140874" sldId="309"/>
            <ac:cxnSpMk id="61" creationId="{60770B83-1127-4F2D-B417-7730032C6158}"/>
          </ac:cxnSpMkLst>
        </pc:cxnChg>
        <pc:cxnChg chg="mod topLvl">
          <ac:chgData name="Sara Weis" userId="6a51f4e6-0e93-4a18-834c-a49e1ed77407" providerId="ADAL" clId="{6959E033-7E6A-4EA0-AB19-75F676599088}" dt="2025-01-02T17:00:26.168" v="180" actId="164"/>
          <ac:cxnSpMkLst>
            <pc:docMk/>
            <pc:sldMk cId="1407140874" sldId="309"/>
            <ac:cxnSpMk id="65" creationId="{36869760-8BC8-400F-9233-EDB338402EF1}"/>
          </ac:cxnSpMkLst>
        </pc:cxnChg>
        <pc:cxnChg chg="mod topLvl">
          <ac:chgData name="Sara Weis" userId="6a51f4e6-0e93-4a18-834c-a49e1ed77407" providerId="ADAL" clId="{6959E033-7E6A-4EA0-AB19-75F676599088}" dt="2025-01-02T17:00:26.168" v="180" actId="164"/>
          <ac:cxnSpMkLst>
            <pc:docMk/>
            <pc:sldMk cId="1407140874" sldId="309"/>
            <ac:cxnSpMk id="68" creationId="{8162CB15-C774-43CB-8E29-6C531374815F}"/>
          </ac:cxnSpMkLst>
        </pc:cxnChg>
      </pc:sldChg>
      <pc:sldChg chg="addSp delSp modSp del">
        <pc:chgData name="Sara Weis" userId="6a51f4e6-0e93-4a18-834c-a49e1ed77407" providerId="ADAL" clId="{6959E033-7E6A-4EA0-AB19-75F676599088}" dt="2025-01-02T17:23:24.763" v="425" actId="2696"/>
        <pc:sldMkLst>
          <pc:docMk/>
          <pc:sldMk cId="2712744224" sldId="311"/>
        </pc:sldMkLst>
        <pc:spChg chg="add mod">
          <ac:chgData name="Sara Weis" userId="6a51f4e6-0e93-4a18-834c-a49e1ed77407" providerId="ADAL" clId="{6959E033-7E6A-4EA0-AB19-75F676599088}" dt="2025-01-02T17:16:49.358" v="390" actId="403"/>
          <ac:spMkLst>
            <pc:docMk/>
            <pc:sldMk cId="2712744224" sldId="311"/>
            <ac:spMk id="2" creationId="{8FEA17E4-D707-40D4-B8A6-05A0F86B4ED8}"/>
          </ac:spMkLst>
        </pc:spChg>
        <pc:spChg chg="del">
          <ac:chgData name="Sara Weis" userId="6a51f4e6-0e93-4a18-834c-a49e1ed77407" providerId="ADAL" clId="{6959E033-7E6A-4EA0-AB19-75F676599088}" dt="2025-01-02T17:04:36.070" v="335" actId="478"/>
          <ac:spMkLst>
            <pc:docMk/>
            <pc:sldMk cId="2712744224" sldId="311"/>
            <ac:spMk id="4" creationId="{EFF1A090-F7E6-4492-A0E2-DB77C11864EC}"/>
          </ac:spMkLst>
        </pc:spChg>
        <pc:spChg chg="del">
          <ac:chgData name="Sara Weis" userId="6a51f4e6-0e93-4a18-834c-a49e1ed77407" providerId="ADAL" clId="{6959E033-7E6A-4EA0-AB19-75F676599088}" dt="2025-01-02T17:04:05.317" v="293" actId="478"/>
          <ac:spMkLst>
            <pc:docMk/>
            <pc:sldMk cId="2712744224" sldId="311"/>
            <ac:spMk id="8" creationId="{176DA74B-212B-4CD8-AD83-20D4227BE0BE}"/>
          </ac:spMkLst>
        </pc:spChg>
        <pc:spChg chg="add del mod">
          <ac:chgData name="Sara Weis" userId="6a51f4e6-0e93-4a18-834c-a49e1ed77407" providerId="ADAL" clId="{6959E033-7E6A-4EA0-AB19-75F676599088}" dt="2025-01-02T17:04:53.166" v="342" actId="478"/>
          <ac:spMkLst>
            <pc:docMk/>
            <pc:sldMk cId="2712744224" sldId="311"/>
            <ac:spMk id="31" creationId="{C56981B2-F415-4A9E-A873-F7DE5E9788A4}"/>
          </ac:spMkLst>
        </pc:spChg>
        <pc:grpChg chg="del">
          <ac:chgData name="Sara Weis" userId="6a51f4e6-0e93-4a18-834c-a49e1ed77407" providerId="ADAL" clId="{6959E033-7E6A-4EA0-AB19-75F676599088}" dt="2025-01-02T17:04:05.317" v="293" actId="478"/>
          <ac:grpSpMkLst>
            <pc:docMk/>
            <pc:sldMk cId="2712744224" sldId="311"/>
            <ac:grpSpMk id="17" creationId="{3AD46ADA-27C5-4509-BC5D-8E2838B8B03B}"/>
          </ac:grpSpMkLst>
        </pc:grpChg>
        <pc:grpChg chg="del">
          <ac:chgData name="Sara Weis" userId="6a51f4e6-0e93-4a18-834c-a49e1ed77407" providerId="ADAL" clId="{6959E033-7E6A-4EA0-AB19-75F676599088}" dt="2025-01-02T17:04:05.317" v="293" actId="478"/>
          <ac:grpSpMkLst>
            <pc:docMk/>
            <pc:sldMk cId="2712744224" sldId="311"/>
            <ac:grpSpMk id="32" creationId="{AEFCE027-3D20-461D-B064-12E9E1F01B51}"/>
          </ac:grpSpMkLst>
        </pc:grpChg>
        <pc:graphicFrameChg chg="del">
          <ac:chgData name="Sara Weis" userId="6a51f4e6-0e93-4a18-834c-a49e1ed77407" providerId="ADAL" clId="{6959E033-7E6A-4EA0-AB19-75F676599088}" dt="2025-01-02T17:04:05.317" v="293" actId="478"/>
          <ac:graphicFrameMkLst>
            <pc:docMk/>
            <pc:sldMk cId="2712744224" sldId="311"/>
            <ac:graphicFrameMk id="66" creationId="{111A6526-7355-44C6-8032-64EE94B50FD5}"/>
          </ac:graphicFrameMkLst>
        </pc:graphicFrameChg>
        <pc:picChg chg="mod">
          <ac:chgData name="Sara Weis" userId="6a51f4e6-0e93-4a18-834c-a49e1ed77407" providerId="ADAL" clId="{6959E033-7E6A-4EA0-AB19-75F676599088}" dt="2025-01-02T17:16:52.628" v="391" actId="1076"/>
          <ac:picMkLst>
            <pc:docMk/>
            <pc:sldMk cId="2712744224" sldId="311"/>
            <ac:picMk id="7" creationId="{1351158B-83E9-448C-978B-1EA485DEA316}"/>
          </ac:picMkLst>
        </pc:picChg>
        <pc:cxnChg chg="del">
          <ac:chgData name="Sara Weis" userId="6a51f4e6-0e93-4a18-834c-a49e1ed77407" providerId="ADAL" clId="{6959E033-7E6A-4EA0-AB19-75F676599088}" dt="2025-01-02T17:04:05.317" v="293" actId="478"/>
          <ac:cxnSpMkLst>
            <pc:docMk/>
            <pc:sldMk cId="2712744224" sldId="311"/>
            <ac:cxnSpMk id="67" creationId="{900452E5-2F38-400C-871D-592F39BB8149}"/>
          </ac:cxnSpMkLst>
        </pc:cxnChg>
      </pc:sldChg>
      <pc:sldChg chg="addSp delSp modSp add">
        <pc:chgData name="Sara Weis" userId="6a51f4e6-0e93-4a18-834c-a49e1ed77407" providerId="ADAL" clId="{6959E033-7E6A-4EA0-AB19-75F676599088}" dt="2025-01-02T17:17:59.407" v="418" actId="20577"/>
        <pc:sldMkLst>
          <pc:docMk/>
          <pc:sldMk cId="2356307124" sldId="312"/>
        </pc:sldMkLst>
        <pc:spChg chg="add mod">
          <ac:chgData name="Sara Weis" userId="6a51f4e6-0e93-4a18-834c-a49e1ed77407" providerId="ADAL" clId="{6959E033-7E6A-4EA0-AB19-75F676599088}" dt="2025-01-02T17:17:59.407" v="418" actId="20577"/>
          <ac:spMkLst>
            <pc:docMk/>
            <pc:sldMk cId="2356307124" sldId="312"/>
            <ac:spMk id="2" creationId="{4D9D5902-05D5-4827-AE64-44E64AA62EA2}"/>
          </ac:spMkLst>
        </pc:spChg>
        <pc:spChg chg="del">
          <ac:chgData name="Sara Weis" userId="6a51f4e6-0e93-4a18-834c-a49e1ed77407" providerId="ADAL" clId="{6959E033-7E6A-4EA0-AB19-75F676599088}" dt="2025-01-02T17:02:44.579" v="235" actId="478"/>
          <ac:spMkLst>
            <pc:docMk/>
            <pc:sldMk cId="2356307124" sldId="312"/>
            <ac:spMk id="4" creationId="{EFF1A090-F7E6-4492-A0E2-DB77C11864EC}"/>
          </ac:spMkLst>
        </pc:spChg>
        <pc:spChg chg="del">
          <ac:chgData name="Sara Weis" userId="6a51f4e6-0e93-4a18-834c-a49e1ed77407" providerId="ADAL" clId="{6959E033-7E6A-4EA0-AB19-75F676599088}" dt="2025-01-02T17:02:49.963" v="238" actId="478"/>
          <ac:spMkLst>
            <pc:docMk/>
            <pc:sldMk cId="2356307124" sldId="312"/>
            <ac:spMk id="8" creationId="{176DA74B-212B-4CD8-AD83-20D4227BE0BE}"/>
          </ac:spMkLst>
        </pc:spChg>
        <pc:spChg chg="del mod">
          <ac:chgData name="Sara Weis" userId="6a51f4e6-0e93-4a18-834c-a49e1ed77407" providerId="ADAL" clId="{6959E033-7E6A-4EA0-AB19-75F676599088}" dt="2025-01-02T17:04:58.125" v="343" actId="478"/>
          <ac:spMkLst>
            <pc:docMk/>
            <pc:sldMk cId="2356307124" sldId="312"/>
            <ac:spMk id="31" creationId="{C56981B2-F415-4A9E-A873-F7DE5E9788A4}"/>
          </ac:spMkLst>
        </pc:spChg>
        <pc:spChg chg="mod">
          <ac:chgData name="Sara Weis" userId="6a51f4e6-0e93-4a18-834c-a49e1ed77407" providerId="ADAL" clId="{6959E033-7E6A-4EA0-AB19-75F676599088}" dt="2025-01-02T17:17:16.576" v="404" actId="404"/>
          <ac:spMkLst>
            <pc:docMk/>
            <pc:sldMk cId="2356307124" sldId="312"/>
            <ac:spMk id="34" creationId="{7245DFBF-E367-42CE-9BC0-1CC284935543}"/>
          </ac:spMkLst>
        </pc:spChg>
        <pc:spChg chg="mod">
          <ac:chgData name="Sara Weis" userId="6a51f4e6-0e93-4a18-834c-a49e1ed77407" providerId="ADAL" clId="{6959E033-7E6A-4EA0-AB19-75F676599088}" dt="2025-01-02T17:17:20.827" v="405" actId="1076"/>
          <ac:spMkLst>
            <pc:docMk/>
            <pc:sldMk cId="2356307124" sldId="312"/>
            <ac:spMk id="35" creationId="{FF84D828-1683-4212-9A04-530622F68783}"/>
          </ac:spMkLst>
        </pc:spChg>
        <pc:spChg chg="mod">
          <ac:chgData name="Sara Weis" userId="6a51f4e6-0e93-4a18-834c-a49e1ed77407" providerId="ADAL" clId="{6959E033-7E6A-4EA0-AB19-75F676599088}" dt="2025-01-02T17:17:24.806" v="407" actId="14100"/>
          <ac:spMkLst>
            <pc:docMk/>
            <pc:sldMk cId="2356307124" sldId="312"/>
            <ac:spMk id="36" creationId="{1FC9477D-6E24-442C-9FA5-58E70ABD35D1}"/>
          </ac:spMkLst>
        </pc:spChg>
        <pc:spChg chg="mod">
          <ac:chgData name="Sara Weis" userId="6a51f4e6-0e93-4a18-834c-a49e1ed77407" providerId="ADAL" clId="{6959E033-7E6A-4EA0-AB19-75F676599088}" dt="2025-01-02T17:17:27.382" v="408" actId="1076"/>
          <ac:spMkLst>
            <pc:docMk/>
            <pc:sldMk cId="2356307124" sldId="312"/>
            <ac:spMk id="37" creationId="{77012511-9E81-45CF-B84C-A520A6C63417}"/>
          </ac:spMkLst>
        </pc:spChg>
        <pc:spChg chg="mod">
          <ac:chgData name="Sara Weis" userId="6a51f4e6-0e93-4a18-834c-a49e1ed77407" providerId="ADAL" clId="{6959E033-7E6A-4EA0-AB19-75F676599088}" dt="2025-01-02T17:17:16.576" v="404" actId="404"/>
          <ac:spMkLst>
            <pc:docMk/>
            <pc:sldMk cId="2356307124" sldId="312"/>
            <ac:spMk id="38" creationId="{3DB68739-9E51-4261-B67F-EEB63C4BA948}"/>
          </ac:spMkLst>
        </pc:spChg>
        <pc:spChg chg="mod">
          <ac:chgData name="Sara Weis" userId="6a51f4e6-0e93-4a18-834c-a49e1ed77407" providerId="ADAL" clId="{6959E033-7E6A-4EA0-AB19-75F676599088}" dt="2025-01-02T17:17:16.576" v="404" actId="404"/>
          <ac:spMkLst>
            <pc:docMk/>
            <pc:sldMk cId="2356307124" sldId="312"/>
            <ac:spMk id="39" creationId="{B5400EC5-E183-4B29-A883-E4711603516E}"/>
          </ac:spMkLst>
        </pc:spChg>
        <pc:grpChg chg="add del mod">
          <ac:chgData name="Sara Weis" userId="6a51f4e6-0e93-4a18-834c-a49e1ed77407" providerId="ADAL" clId="{6959E033-7E6A-4EA0-AB19-75F676599088}" dt="2025-01-02T17:17:10.519" v="396" actId="165"/>
          <ac:grpSpMkLst>
            <pc:docMk/>
            <pc:sldMk cId="2356307124" sldId="312"/>
            <ac:grpSpMk id="5" creationId="{F0736E05-44C9-4E0F-B450-06399BD2E38F}"/>
          </ac:grpSpMkLst>
        </pc:grpChg>
        <pc:grpChg chg="mod topLvl">
          <ac:chgData name="Sara Weis" userId="6a51f4e6-0e93-4a18-834c-a49e1ed77407" providerId="ADAL" clId="{6959E033-7E6A-4EA0-AB19-75F676599088}" dt="2025-01-02T17:17:52.766" v="415" actId="1076"/>
          <ac:grpSpMkLst>
            <pc:docMk/>
            <pc:sldMk cId="2356307124" sldId="312"/>
            <ac:grpSpMk id="17" creationId="{3AD46ADA-27C5-4509-BC5D-8E2838B8B03B}"/>
          </ac:grpSpMkLst>
        </pc:grpChg>
        <pc:grpChg chg="mod topLvl">
          <ac:chgData name="Sara Weis" userId="6a51f4e6-0e93-4a18-834c-a49e1ed77407" providerId="ADAL" clId="{6959E033-7E6A-4EA0-AB19-75F676599088}" dt="2025-01-02T17:17:52.766" v="415" actId="1076"/>
          <ac:grpSpMkLst>
            <pc:docMk/>
            <pc:sldMk cId="2356307124" sldId="312"/>
            <ac:grpSpMk id="32" creationId="{AEFCE027-3D20-461D-B064-12E9E1F01B51}"/>
          </ac:grpSpMkLst>
        </pc:grpChg>
        <pc:grpChg chg="mod">
          <ac:chgData name="Sara Weis" userId="6a51f4e6-0e93-4a18-834c-a49e1ed77407" providerId="ADAL" clId="{6959E033-7E6A-4EA0-AB19-75F676599088}" dt="2025-01-02T17:17:52.766" v="415" actId="1076"/>
          <ac:grpSpMkLst>
            <pc:docMk/>
            <pc:sldMk cId="2356307124" sldId="312"/>
            <ac:grpSpMk id="33" creationId="{2ED8BAA9-40D7-40CC-906F-F42E40F72D84}"/>
          </ac:grpSpMkLst>
        </pc:grpChg>
        <pc:graphicFrameChg chg="mod topLvl">
          <ac:chgData name="Sara Weis" userId="6a51f4e6-0e93-4a18-834c-a49e1ed77407" providerId="ADAL" clId="{6959E033-7E6A-4EA0-AB19-75F676599088}" dt="2025-01-02T17:17:52.766" v="415" actId="1076"/>
          <ac:graphicFrameMkLst>
            <pc:docMk/>
            <pc:sldMk cId="2356307124" sldId="312"/>
            <ac:graphicFrameMk id="66" creationId="{111A6526-7355-44C6-8032-64EE94B50FD5}"/>
          </ac:graphicFrameMkLst>
        </pc:graphicFrameChg>
        <pc:picChg chg="mod">
          <ac:chgData name="Sara Weis" userId="6a51f4e6-0e93-4a18-834c-a49e1ed77407" providerId="ADAL" clId="{6959E033-7E6A-4EA0-AB19-75F676599088}" dt="2025-01-02T17:05:17.936" v="349" actId="1076"/>
          <ac:picMkLst>
            <pc:docMk/>
            <pc:sldMk cId="2356307124" sldId="312"/>
            <ac:picMk id="3" creationId="{A6327666-5840-B3BB-17A2-7B4D54247304}"/>
          </ac:picMkLst>
        </pc:picChg>
        <pc:picChg chg="del">
          <ac:chgData name="Sara Weis" userId="6a51f4e6-0e93-4a18-834c-a49e1ed77407" providerId="ADAL" clId="{6959E033-7E6A-4EA0-AB19-75F676599088}" dt="2025-01-02T17:02:44.579" v="235" actId="478"/>
          <ac:picMkLst>
            <pc:docMk/>
            <pc:sldMk cId="2356307124" sldId="312"/>
            <ac:picMk id="7" creationId="{1351158B-83E9-448C-978B-1EA485DEA316}"/>
          </ac:picMkLst>
        </pc:picChg>
        <pc:cxnChg chg="mod topLvl">
          <ac:chgData name="Sara Weis" userId="6a51f4e6-0e93-4a18-834c-a49e1ed77407" providerId="ADAL" clId="{6959E033-7E6A-4EA0-AB19-75F676599088}" dt="2025-01-02T17:17:52.766" v="415" actId="1076"/>
          <ac:cxnSpMkLst>
            <pc:docMk/>
            <pc:sldMk cId="2356307124" sldId="312"/>
            <ac:cxnSpMk id="67" creationId="{900452E5-2F38-400C-871D-592F39BB8149}"/>
          </ac:cxnSpMkLst>
        </pc:cxnChg>
      </pc:sldChg>
    </pc:docChg>
  </pc:docChgLst>
  <pc:docChgLst>
    <pc:chgData name="Sara Weis" userId="6a51f4e6-0e93-4a18-834c-a49e1ed77407" providerId="ADAL" clId="{5B9D748F-4140-4F29-A6FB-884F3F5921E6}"/>
    <pc:docChg chg="delSld modSld">
      <pc:chgData name="Sara Weis" userId="6a51f4e6-0e93-4a18-834c-a49e1ed77407" providerId="ADAL" clId="{5B9D748F-4140-4F29-A6FB-884F3F5921E6}" dt="2025-01-02T16:47:04.763" v="12" actId="20577"/>
      <pc:docMkLst>
        <pc:docMk/>
      </pc:docMkLst>
      <pc:sldChg chg="modSp">
        <pc:chgData name="Sara Weis" userId="6a51f4e6-0e93-4a18-834c-a49e1ed77407" providerId="ADAL" clId="{5B9D748F-4140-4F29-A6FB-884F3F5921E6}" dt="2025-01-02T16:46:55.225" v="6" actId="20577"/>
        <pc:sldMkLst>
          <pc:docMk/>
          <pc:sldMk cId="2106248321" sldId="298"/>
        </pc:sldMkLst>
        <pc:spChg chg="mod">
          <ac:chgData name="Sara Weis" userId="6a51f4e6-0e93-4a18-834c-a49e1ed77407" providerId="ADAL" clId="{5B9D748F-4140-4F29-A6FB-884F3F5921E6}" dt="2025-01-02T16:46:52.776" v="4" actId="20577"/>
          <ac:spMkLst>
            <pc:docMk/>
            <pc:sldMk cId="2106248321" sldId="298"/>
            <ac:spMk id="23" creationId="{9837469B-6902-495A-86E3-722D7C6A57DC}"/>
          </ac:spMkLst>
        </pc:spChg>
        <pc:spChg chg="mod">
          <ac:chgData name="Sara Weis" userId="6a51f4e6-0e93-4a18-834c-a49e1ed77407" providerId="ADAL" clId="{5B9D748F-4140-4F29-A6FB-884F3F5921E6}" dt="2025-01-02T16:46:48.408" v="2" actId="20577"/>
          <ac:spMkLst>
            <pc:docMk/>
            <pc:sldMk cId="2106248321" sldId="298"/>
            <ac:spMk id="45" creationId="{F3A9156C-C54C-4614-ABB9-5AF095F0F775}"/>
          </ac:spMkLst>
        </pc:spChg>
        <pc:spChg chg="mod">
          <ac:chgData name="Sara Weis" userId="6a51f4e6-0e93-4a18-834c-a49e1ed77407" providerId="ADAL" clId="{5B9D748F-4140-4F29-A6FB-884F3F5921E6}" dt="2025-01-02T16:46:55.225" v="6" actId="20577"/>
          <ac:spMkLst>
            <pc:docMk/>
            <pc:sldMk cId="2106248321" sldId="298"/>
            <ac:spMk id="70" creationId="{7A30D47F-4FE9-4840-9977-6022DD4A371A}"/>
          </ac:spMkLst>
        </pc:spChg>
      </pc:sldChg>
      <pc:sldChg chg="del">
        <pc:chgData name="Sara Weis" userId="6a51f4e6-0e93-4a18-834c-a49e1ed77407" providerId="ADAL" clId="{5B9D748F-4140-4F29-A6FB-884F3F5921E6}" dt="2025-01-02T16:46:43.245" v="0" actId="2696"/>
        <pc:sldMkLst>
          <pc:docMk/>
          <pc:sldMk cId="3697787146" sldId="301"/>
        </pc:sldMkLst>
      </pc:sldChg>
      <pc:sldChg chg="modSp">
        <pc:chgData name="Sara Weis" userId="6a51f4e6-0e93-4a18-834c-a49e1ed77407" providerId="ADAL" clId="{5B9D748F-4140-4F29-A6FB-884F3F5921E6}" dt="2025-01-02T16:46:58.680" v="8" actId="20577"/>
        <pc:sldMkLst>
          <pc:docMk/>
          <pc:sldMk cId="1407140874" sldId="309"/>
        </pc:sldMkLst>
        <pc:spChg chg="mod">
          <ac:chgData name="Sara Weis" userId="6a51f4e6-0e93-4a18-834c-a49e1ed77407" providerId="ADAL" clId="{5B9D748F-4140-4F29-A6FB-884F3F5921E6}" dt="2025-01-02T16:46:58.680" v="8" actId="20577"/>
          <ac:spMkLst>
            <pc:docMk/>
            <pc:sldMk cId="1407140874" sldId="309"/>
            <ac:spMk id="5" creationId="{B847A6B5-FE3F-456F-A592-96E2D8DDCCD8}"/>
          </ac:spMkLst>
        </pc:spChg>
      </pc:sldChg>
      <pc:sldChg chg="modSp">
        <pc:chgData name="Sara Weis" userId="6a51f4e6-0e93-4a18-834c-a49e1ed77407" providerId="ADAL" clId="{5B9D748F-4140-4F29-A6FB-884F3F5921E6}" dt="2025-01-02T16:47:04.763" v="12" actId="20577"/>
        <pc:sldMkLst>
          <pc:docMk/>
          <pc:sldMk cId="2712744224" sldId="311"/>
        </pc:sldMkLst>
        <pc:spChg chg="mod">
          <ac:chgData name="Sara Weis" userId="6a51f4e6-0e93-4a18-834c-a49e1ed77407" providerId="ADAL" clId="{5B9D748F-4140-4F29-A6FB-884F3F5921E6}" dt="2025-01-02T16:47:02.568" v="10" actId="20577"/>
          <ac:spMkLst>
            <pc:docMk/>
            <pc:sldMk cId="2712744224" sldId="311"/>
            <ac:spMk id="4" creationId="{EFF1A090-F7E6-4492-A0E2-DB77C11864EC}"/>
          </ac:spMkLst>
        </pc:spChg>
        <pc:spChg chg="mod">
          <ac:chgData name="Sara Weis" userId="6a51f4e6-0e93-4a18-834c-a49e1ed77407" providerId="ADAL" clId="{5B9D748F-4140-4F29-A6FB-884F3F5921E6}" dt="2025-01-02T16:47:04.763" v="12" actId="20577"/>
          <ac:spMkLst>
            <pc:docMk/>
            <pc:sldMk cId="2712744224" sldId="311"/>
            <ac:spMk id="8" creationId="{176DA74B-212B-4CD8-AD83-20D4227BE0BE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ucsdhs-my.sharepoint.com/personal/sweis_health_ucsd_edu/Documents/Desktop%20(office%20PC)/Image%20Analysis/Measurement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measure stack all (remove outl)'!$J$1</c:f>
              <c:strCache>
                <c:ptCount val="1"/>
                <c:pt idx="0">
                  <c:v>Green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easure stack all (remove outl)'!$M$2:$M$7</c:f>
                <c:numCache>
                  <c:formatCode>General</c:formatCode>
                  <c:ptCount val="6"/>
                  <c:pt idx="0">
                    <c:v>0.66680169465891281</c:v>
                  </c:pt>
                  <c:pt idx="1">
                    <c:v>1.076216520965926</c:v>
                  </c:pt>
                  <c:pt idx="2">
                    <c:v>0.22748479802688643</c:v>
                  </c:pt>
                  <c:pt idx="3">
                    <c:v>0.55076734350056278</c:v>
                  </c:pt>
                  <c:pt idx="4">
                    <c:v>0.91327633642105488</c:v>
                  </c:pt>
                  <c:pt idx="5">
                    <c:v>0.19233304448274077</c:v>
                  </c:pt>
                </c:numCache>
              </c:numRef>
            </c:plus>
            <c:minus>
              <c:numRef>
                <c:f>'measure stack all (remove outl)'!$M$2:$M$7</c:f>
                <c:numCache>
                  <c:formatCode>General</c:formatCode>
                  <c:ptCount val="6"/>
                  <c:pt idx="0">
                    <c:v>0.66680169465891281</c:v>
                  </c:pt>
                  <c:pt idx="1">
                    <c:v>1.076216520965926</c:v>
                  </c:pt>
                  <c:pt idx="2">
                    <c:v>0.22748479802688643</c:v>
                  </c:pt>
                  <c:pt idx="3">
                    <c:v>0.55076734350056278</c:v>
                  </c:pt>
                  <c:pt idx="4">
                    <c:v>0.91327633642105488</c:v>
                  </c:pt>
                  <c:pt idx="5">
                    <c:v>0.1923330444827407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easure stack all (remove outl)'!$I$2:$I$7</c:f>
              <c:strCache>
                <c:ptCount val="6"/>
                <c:pt idx="0">
                  <c:v>IgG CTRL</c:v>
                </c:pt>
                <c:pt idx="1">
                  <c:v>mAb αvβ3</c:v>
                </c:pt>
                <c:pt idx="2">
                  <c:v>mAb α5β1</c:v>
                </c:pt>
                <c:pt idx="3">
                  <c:v>BsAb</c:v>
                </c:pt>
                <c:pt idx="4">
                  <c:v>mAb Combo (5+5)</c:v>
                </c:pt>
                <c:pt idx="5">
                  <c:v>mAb Combo (10+10)</c:v>
                </c:pt>
              </c:strCache>
            </c:strRef>
          </c:cat>
          <c:val>
            <c:numRef>
              <c:f>'measure stack all (remove outl)'!$J$2:$J$7</c:f>
              <c:numCache>
                <c:formatCode>0.0</c:formatCode>
                <c:ptCount val="6"/>
                <c:pt idx="0">
                  <c:v>24.4895</c:v>
                </c:pt>
                <c:pt idx="1">
                  <c:v>6.774</c:v>
                </c:pt>
                <c:pt idx="2">
                  <c:v>7.3336666666666659</c:v>
                </c:pt>
                <c:pt idx="3">
                  <c:v>6.3010000000000002</c:v>
                </c:pt>
                <c:pt idx="4">
                  <c:v>4.8975</c:v>
                </c:pt>
                <c:pt idx="5">
                  <c:v>3.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A14-4042-95D4-AC90202A432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754591680"/>
        <c:axId val="754592992"/>
      </c:barChart>
      <c:catAx>
        <c:axId val="7545916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754592992"/>
        <c:crosses val="autoZero"/>
        <c:auto val="1"/>
        <c:lblAlgn val="ctr"/>
        <c:lblOffset val="100"/>
        <c:noMultiLvlLbl val="0"/>
      </c:catAx>
      <c:valAx>
        <c:axId val="75459299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400"/>
                  <a:t>Fibronectin (% area)</a:t>
                </a:r>
              </a:p>
            </c:rich>
          </c:tx>
          <c:layout>
            <c:manualLayout>
              <c:xMode val="edge"/>
              <c:yMode val="edge"/>
              <c:x val="2.0544424000675538E-2"/>
              <c:y val="0.1478083989501312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7545916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8556F641-4CF0-450A-AF50-26BA00F47CDE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35238" y="1200150"/>
            <a:ext cx="2244725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1" tIns="48331" rIns="96661" bIns="4833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620577"/>
            <a:ext cx="5852160" cy="3780473"/>
          </a:xfrm>
          <a:prstGeom prst="rect">
            <a:avLst/>
          </a:prstGeom>
        </p:spPr>
        <p:txBody>
          <a:bodyPr vert="horz" lIns="96661" tIns="48331" rIns="96661" bIns="48331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7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306F44C2-743C-4165-B45D-193A312A7D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57285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06F44C2-743C-4165-B45D-193A312A7D2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56644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32504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77690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93299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22919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35701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5906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57310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7151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9967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903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8218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92040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5.wdp"/><Relationship Id="rId3" Type="http://schemas.openxmlformats.org/officeDocument/2006/relationships/image" Target="../media/image1.tiff"/><Relationship Id="rId7" Type="http://schemas.microsoft.com/office/2007/relationships/hdphoto" Target="../media/hdphoto2.wdp"/><Relationship Id="rId12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6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11" Type="http://schemas.microsoft.com/office/2007/relationships/hdphoto" Target="../media/hdphoto4.wdp"/><Relationship Id="rId5" Type="http://schemas.microsoft.com/office/2007/relationships/hdphoto" Target="../media/hdphoto1.wdp"/><Relationship Id="rId15" Type="http://schemas.microsoft.com/office/2007/relationships/hdphoto" Target="../media/hdphoto6.wdp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3.wdp"/><Relationship Id="rId1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 up of a colorful pattern&#10;&#10;Description automatically generated">
            <a:extLst>
              <a:ext uri="{FF2B5EF4-FFF2-40B4-BE49-F238E27FC236}">
                <a16:creationId xmlns:a16="http://schemas.microsoft.com/office/drawing/2014/main" id="{A6327666-5840-B3BB-17A2-7B4D5424730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280160" y="11951880"/>
            <a:ext cx="2743200" cy="2743200"/>
          </a:xfrm>
          <a:prstGeom prst="rect">
            <a:avLst/>
          </a:prstGeom>
        </p:spPr>
      </p:pic>
      <p:grpSp>
        <p:nvGrpSpPr>
          <p:cNvPr id="32" name="Group 31">
            <a:extLst>
              <a:ext uri="{FF2B5EF4-FFF2-40B4-BE49-F238E27FC236}">
                <a16:creationId xmlns:a16="http://schemas.microsoft.com/office/drawing/2014/main" id="{AEFCE027-3D20-461D-B064-12E9E1F01B51}"/>
              </a:ext>
            </a:extLst>
          </p:cNvPr>
          <p:cNvGrpSpPr/>
          <p:nvPr/>
        </p:nvGrpSpPr>
        <p:grpSpPr>
          <a:xfrm>
            <a:off x="0" y="6852821"/>
            <a:ext cx="2569737" cy="1689667"/>
            <a:chOff x="334908" y="4193816"/>
            <a:chExt cx="1232619" cy="1233382"/>
          </a:xfrm>
        </p:grpSpPr>
        <p:grpSp>
          <p:nvGrpSpPr>
            <p:cNvPr id="33" name="Group 3563">
              <a:extLst>
                <a:ext uri="{FF2B5EF4-FFF2-40B4-BE49-F238E27FC236}">
                  <a16:creationId xmlns:a16="http://schemas.microsoft.com/office/drawing/2014/main" id="{2ED8BAA9-40D7-40CC-906F-F42E40F72D84}"/>
                </a:ext>
              </a:extLst>
            </p:cNvPr>
            <p:cNvGrpSpPr>
              <a:grpSpLocks noChangeAspect="1"/>
            </p:cNvGrpSpPr>
            <p:nvPr/>
          </p:nvGrpSpPr>
          <p:grpSpPr bwMode="auto">
            <a:xfrm>
              <a:off x="541117" y="4410660"/>
              <a:ext cx="836612" cy="320675"/>
              <a:chOff x="1920" y="1649"/>
              <a:chExt cx="1753" cy="672"/>
            </a:xfrm>
          </p:grpSpPr>
          <p:sp>
            <p:nvSpPr>
              <p:cNvPr id="38" name="Oval 3564">
                <a:extLst>
                  <a:ext uri="{FF2B5EF4-FFF2-40B4-BE49-F238E27FC236}">
                    <a16:creationId xmlns:a16="http://schemas.microsoft.com/office/drawing/2014/main" id="{3DB68739-9E51-4261-B67F-EEB63C4BA948}"/>
                  </a:ext>
                </a:extLst>
              </p:cNvPr>
              <p:cNvSpPr>
                <a:spLocks noChangeAspect="1" noChangeArrowheads="1"/>
              </p:cNvSpPr>
              <p:nvPr/>
            </p:nvSpPr>
            <p:spPr bwMode="auto">
              <a:xfrm>
                <a:off x="1920" y="1984"/>
                <a:ext cx="1744" cy="336"/>
              </a:xfrm>
              <a:prstGeom prst="ellipse">
                <a:avLst/>
              </a:prstGeom>
              <a:solidFill>
                <a:srgbClr val="EAEAEA"/>
              </a:solidFill>
              <a:ln w="12700">
                <a:solidFill>
                  <a:srgbClr val="EAEAEA"/>
                </a:solidFill>
                <a:round/>
                <a:headEnd/>
                <a:tailEnd/>
              </a:ln>
              <a:effectLst/>
            </p:spPr>
            <p:txBody>
              <a:bodyPr wrap="none" anchor="ctr"/>
              <a:lstStyle/>
              <a:p>
                <a:endParaRPr lang="en-US" sz="1400"/>
              </a:p>
            </p:txBody>
          </p:sp>
          <p:sp>
            <p:nvSpPr>
              <p:cNvPr id="39" name="AutoShape 3565">
                <a:extLst>
                  <a:ext uri="{FF2B5EF4-FFF2-40B4-BE49-F238E27FC236}">
                    <a16:creationId xmlns:a16="http://schemas.microsoft.com/office/drawing/2014/main" id="{B5400EC5-E183-4B29-A883-E4711603516E}"/>
                  </a:ext>
                </a:extLst>
              </p:cNvPr>
              <p:cNvSpPr>
                <a:spLocks noChangeAspect="1" noChangeArrowheads="1"/>
              </p:cNvSpPr>
              <p:nvPr/>
            </p:nvSpPr>
            <p:spPr bwMode="auto">
              <a:xfrm>
                <a:off x="1921" y="1649"/>
                <a:ext cx="1752" cy="672"/>
              </a:xfrm>
              <a:prstGeom prst="can">
                <a:avLst>
                  <a:gd name="adj" fmla="val 50000"/>
                </a:avLst>
              </a:prstGeom>
              <a:noFill/>
              <a:ln w="12700">
                <a:solidFill>
                  <a:srgbClr val="777777"/>
                </a:solidFill>
                <a:round/>
                <a:headEnd/>
                <a:tailEnd/>
              </a:ln>
              <a:effectLst/>
            </p:spPr>
            <p:txBody>
              <a:bodyPr wrap="none" anchor="ctr"/>
              <a:lstStyle/>
              <a:p>
                <a:endParaRPr lang="en-US" sz="1400"/>
              </a:p>
            </p:txBody>
          </p:sp>
        </p:grpSp>
        <p:sp>
          <p:nvSpPr>
            <p:cNvPr id="34" name="Arrow: Down 33">
              <a:extLst>
                <a:ext uri="{FF2B5EF4-FFF2-40B4-BE49-F238E27FC236}">
                  <a16:creationId xmlns:a16="http://schemas.microsoft.com/office/drawing/2014/main" id="{7245DFBF-E367-42CE-9BC0-1CC284935543}"/>
                </a:ext>
              </a:extLst>
            </p:cNvPr>
            <p:cNvSpPr/>
            <p:nvPr/>
          </p:nvSpPr>
          <p:spPr>
            <a:xfrm>
              <a:off x="831982" y="4783018"/>
              <a:ext cx="254882" cy="391923"/>
            </a:xfrm>
            <a:prstGeom prst="downArrow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FF84D828-1683-4212-9A04-530622F68783}"/>
                </a:ext>
              </a:extLst>
            </p:cNvPr>
            <p:cNvSpPr txBox="1"/>
            <p:nvPr/>
          </p:nvSpPr>
          <p:spPr>
            <a:xfrm>
              <a:off x="707099" y="4193816"/>
              <a:ext cx="502128" cy="2246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CAFs + Ab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1FC9477D-6E24-442C-9FA5-58E70ABD35D1}"/>
                </a:ext>
              </a:extLst>
            </p:cNvPr>
            <p:cNvSpPr txBox="1"/>
            <p:nvPr/>
          </p:nvSpPr>
          <p:spPr>
            <a:xfrm>
              <a:off x="1139373" y="4882898"/>
              <a:ext cx="351110" cy="224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72 </a:t>
              </a:r>
              <a:r>
                <a:rPr lang="en-US" sz="14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hrs</a:t>
              </a:r>
              <a:endParaRPr lang="en-US" sz="14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77012511-9E81-45CF-B84C-A520A6C63417}"/>
                </a:ext>
              </a:extLst>
            </p:cNvPr>
            <p:cNvSpPr txBox="1"/>
            <p:nvPr/>
          </p:nvSpPr>
          <p:spPr>
            <a:xfrm>
              <a:off x="334908" y="5202534"/>
              <a:ext cx="1232619" cy="224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Analyze “CAF-ECM”</a:t>
              </a:r>
            </a:p>
          </p:txBody>
        </p:sp>
      </p:grpSp>
      <p:grpSp>
        <p:nvGrpSpPr>
          <p:cNvPr id="17" name="Group 16">
            <a:extLst>
              <a:ext uri="{FF2B5EF4-FFF2-40B4-BE49-F238E27FC236}">
                <a16:creationId xmlns:a16="http://schemas.microsoft.com/office/drawing/2014/main" id="{3AD46ADA-27C5-4509-BC5D-8E2838B8B03B}"/>
              </a:ext>
            </a:extLst>
          </p:cNvPr>
          <p:cNvGrpSpPr/>
          <p:nvPr/>
        </p:nvGrpSpPr>
        <p:grpSpPr>
          <a:xfrm>
            <a:off x="324386" y="1732076"/>
            <a:ext cx="5824312" cy="5061219"/>
            <a:chOff x="2070023" y="3469945"/>
            <a:chExt cx="3284151" cy="2853867"/>
          </a:xfrm>
        </p:grpSpPr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0D2F6CFB-5B58-466E-A6F2-67D94A34A267}"/>
                </a:ext>
              </a:extLst>
            </p:cNvPr>
            <p:cNvSpPr txBox="1"/>
            <p:nvPr/>
          </p:nvSpPr>
          <p:spPr>
            <a:xfrm>
              <a:off x="3135839" y="4753280"/>
              <a:ext cx="1091202" cy="201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Ab combo 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(5+5)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7914F472-3890-4D4E-A9A2-59785C266EC9}"/>
                </a:ext>
              </a:extLst>
            </p:cNvPr>
            <p:cNvSpPr txBox="1"/>
            <p:nvPr/>
          </p:nvSpPr>
          <p:spPr>
            <a:xfrm>
              <a:off x="3161495" y="3471224"/>
              <a:ext cx="1047457" cy="201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Ab </a:t>
              </a:r>
              <a:r>
                <a:rPr lang="el-GR" sz="12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v</a:t>
              </a:r>
              <a:r>
                <a:rPr lang="el-GR" sz="12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B835328F-75D0-4361-94EE-773CB55434D4}"/>
                </a:ext>
              </a:extLst>
            </p:cNvPr>
            <p:cNvSpPr txBox="1"/>
            <p:nvPr/>
          </p:nvSpPr>
          <p:spPr>
            <a:xfrm>
              <a:off x="2102556" y="4754096"/>
              <a:ext cx="1038606" cy="201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sAb (</a:t>
              </a:r>
              <a:r>
                <a:rPr lang="el-GR" sz="12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v</a:t>
              </a:r>
              <a:r>
                <a:rPr lang="el-GR" sz="12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3/</a:t>
              </a:r>
              <a:r>
                <a:rPr lang="el-GR" sz="1200" dirty="0">
                  <a:latin typeface="Arial" panose="020B0604020202020204" pitchFamily="34" charset="0"/>
                  <a:cs typeface="Arial" panose="020B0604020202020204" pitchFamily="34" charset="0"/>
                </a:rPr>
                <a:t>α5β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)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AB7B5472-4A6D-40BE-A345-ABFBDEAE5468}"/>
                </a:ext>
              </a:extLst>
            </p:cNvPr>
            <p:cNvSpPr txBox="1"/>
            <p:nvPr/>
          </p:nvSpPr>
          <p:spPr>
            <a:xfrm>
              <a:off x="4259394" y="3471224"/>
              <a:ext cx="1033462" cy="201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Ab </a:t>
              </a:r>
              <a:r>
                <a:rPr lang="el-GR" sz="1200" dirty="0">
                  <a:latin typeface="Arial" panose="020B0604020202020204" pitchFamily="34" charset="0"/>
                  <a:cs typeface="Arial" panose="020B0604020202020204" pitchFamily="34" charset="0"/>
                </a:rPr>
                <a:t>α5β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7A118671-67C1-4674-B2D5-D9C0A34937B1}"/>
                </a:ext>
              </a:extLst>
            </p:cNvPr>
            <p:cNvSpPr txBox="1"/>
            <p:nvPr/>
          </p:nvSpPr>
          <p:spPr>
            <a:xfrm>
              <a:off x="2071625" y="3469945"/>
              <a:ext cx="1050758" cy="201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IgG CTRL</a:t>
              </a:r>
            </a:p>
          </p:txBody>
        </p:sp>
        <p:pic>
          <p:nvPicPr>
            <p:cNvPr id="57" name="Picture 56">
              <a:extLst>
                <a:ext uri="{FF2B5EF4-FFF2-40B4-BE49-F238E27FC236}">
                  <a16:creationId xmlns:a16="http://schemas.microsoft.com/office/drawing/2014/main" id="{801CBC94-1F70-44A1-A040-89A6C51C791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817" t="45817"/>
            <a:stretch/>
          </p:blipFill>
          <p:spPr>
            <a:xfrm>
              <a:off x="3164253" y="4936864"/>
              <a:ext cx="1048048" cy="1048048"/>
            </a:xfrm>
            <a:prstGeom prst="rect">
              <a:avLst/>
            </a:prstGeom>
          </p:spPr>
        </p:pic>
        <p:pic>
          <p:nvPicPr>
            <p:cNvPr id="58" name="Picture 57">
              <a:extLst>
                <a:ext uri="{FF2B5EF4-FFF2-40B4-BE49-F238E27FC236}">
                  <a16:creationId xmlns:a16="http://schemas.microsoft.com/office/drawing/2014/main" id="{53971E84-443A-4EF0-A4E6-2C28D05034C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817" t="45817"/>
            <a:stretch/>
          </p:blipFill>
          <p:spPr>
            <a:xfrm>
              <a:off x="4244808" y="4936864"/>
              <a:ext cx="1048048" cy="1048048"/>
            </a:xfrm>
            <a:prstGeom prst="rect">
              <a:avLst/>
            </a:prstGeom>
          </p:spPr>
        </p:pic>
        <p:pic>
          <p:nvPicPr>
            <p:cNvPr id="59" name="Picture 58">
              <a:extLst>
                <a:ext uri="{FF2B5EF4-FFF2-40B4-BE49-F238E27FC236}">
                  <a16:creationId xmlns:a16="http://schemas.microsoft.com/office/drawing/2014/main" id="{1453926D-DE1D-4368-921E-93885FE6C33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864" t="45864"/>
            <a:stretch/>
          </p:blipFill>
          <p:spPr>
            <a:xfrm>
              <a:off x="3164844" y="3664214"/>
              <a:ext cx="1047457" cy="1047458"/>
            </a:xfrm>
            <a:prstGeom prst="rect">
              <a:avLst/>
            </a:prstGeom>
          </p:spPr>
        </p:pic>
        <p:pic>
          <p:nvPicPr>
            <p:cNvPr id="60" name="Picture 59">
              <a:extLst>
                <a:ext uri="{FF2B5EF4-FFF2-40B4-BE49-F238E27FC236}">
                  <a16:creationId xmlns:a16="http://schemas.microsoft.com/office/drawing/2014/main" id="{6871BEAD-6939-4725-802E-F9750C35DEB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833" t="45833"/>
            <a:stretch/>
          </p:blipFill>
          <p:spPr>
            <a:xfrm>
              <a:off x="2070023" y="4937184"/>
              <a:ext cx="1048048" cy="1048048"/>
            </a:xfrm>
            <a:prstGeom prst="rect">
              <a:avLst/>
            </a:prstGeom>
          </p:spPr>
        </p:pic>
        <p:pic>
          <p:nvPicPr>
            <p:cNvPr id="61" name="Picture 60">
              <a:extLst>
                <a:ext uri="{FF2B5EF4-FFF2-40B4-BE49-F238E27FC236}">
                  <a16:creationId xmlns:a16="http://schemas.microsoft.com/office/drawing/2014/main" id="{C9B08587-8CAD-44E2-9236-584D9FE80FB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864" t="45864"/>
            <a:stretch/>
          </p:blipFill>
          <p:spPr>
            <a:xfrm>
              <a:off x="4256045" y="3663894"/>
              <a:ext cx="1047457" cy="1047458"/>
            </a:xfrm>
            <a:prstGeom prst="rect">
              <a:avLst/>
            </a:prstGeom>
          </p:spPr>
        </p:pic>
        <p:pic>
          <p:nvPicPr>
            <p:cNvPr id="62" name="Picture 61">
              <a:extLst>
                <a:ext uri="{FF2B5EF4-FFF2-40B4-BE49-F238E27FC236}">
                  <a16:creationId xmlns:a16="http://schemas.microsoft.com/office/drawing/2014/main" id="{B4FC1D83-B5A4-4A57-93EB-CBF2669056C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864" t="45864"/>
            <a:stretch/>
          </p:blipFill>
          <p:spPr>
            <a:xfrm>
              <a:off x="2074925" y="3666452"/>
              <a:ext cx="1047457" cy="1047458"/>
            </a:xfrm>
            <a:prstGeom prst="rect">
              <a:avLst/>
            </a:prstGeom>
          </p:spPr>
        </p:pic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FE746B32-DA16-4E49-A198-8687C89C5AF1}"/>
                </a:ext>
              </a:extLst>
            </p:cNvPr>
            <p:cNvSpPr txBox="1"/>
            <p:nvPr/>
          </p:nvSpPr>
          <p:spPr>
            <a:xfrm>
              <a:off x="4223231" y="4752960"/>
              <a:ext cx="1130943" cy="201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Ab combo 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(10+10)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5" name="Straight Connector 64">
              <a:extLst>
                <a:ext uri="{FF2B5EF4-FFF2-40B4-BE49-F238E27FC236}">
                  <a16:creationId xmlns:a16="http://schemas.microsoft.com/office/drawing/2014/main" id="{4683F14F-CE2F-4CD5-8576-7EFD9A1B06EA}"/>
                </a:ext>
              </a:extLst>
            </p:cNvPr>
            <p:cNvCxnSpPr/>
            <p:nvPr/>
          </p:nvCxnSpPr>
          <p:spPr>
            <a:xfrm>
              <a:off x="4939136" y="6106819"/>
              <a:ext cx="310716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B15BBA01-EA4D-437E-A516-4A06CA128900}"/>
                </a:ext>
              </a:extLst>
            </p:cNvPr>
            <p:cNvSpPr txBox="1"/>
            <p:nvPr/>
          </p:nvSpPr>
          <p:spPr>
            <a:xfrm>
              <a:off x="4682754" y="6133643"/>
              <a:ext cx="671420" cy="1901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solidFill>
                    <a:schemeClr val="accent6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reen = FN</a:t>
              </a:r>
              <a:endParaRPr lang="en-US" sz="11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66" name="Chart 65">
            <a:extLst>
              <a:ext uri="{FF2B5EF4-FFF2-40B4-BE49-F238E27FC236}">
                <a16:creationId xmlns:a16="http://schemas.microsoft.com/office/drawing/2014/main" id="{111A6526-7355-44C6-8032-64EE94B50FD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46045306"/>
              </p:ext>
            </p:extLst>
          </p:nvPr>
        </p:nvGraphicFramePr>
        <p:xfrm>
          <a:off x="2905435" y="6298539"/>
          <a:ext cx="3243263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900452E5-2F38-400C-871D-592F39BB8149}"/>
              </a:ext>
            </a:extLst>
          </p:cNvPr>
          <p:cNvCxnSpPr/>
          <p:nvPr/>
        </p:nvCxnSpPr>
        <p:spPr>
          <a:xfrm>
            <a:off x="3967473" y="6836702"/>
            <a:ext cx="1981200" cy="0"/>
          </a:xfrm>
          <a:prstGeom prst="line">
            <a:avLst/>
          </a:prstGeom>
          <a:ln>
            <a:prstDash val="lg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" name="Rectangle 1">
            <a:extLst>
              <a:ext uri="{FF2B5EF4-FFF2-40B4-BE49-F238E27FC236}">
                <a16:creationId xmlns:a16="http://schemas.microsoft.com/office/drawing/2014/main" id="{4D9D5902-05D5-4827-AE64-44E64AA62EA2}"/>
              </a:ext>
            </a:extLst>
          </p:cNvPr>
          <p:cNvSpPr/>
          <p:nvPr/>
        </p:nvSpPr>
        <p:spPr>
          <a:xfrm>
            <a:off x="165537" y="135286"/>
            <a:ext cx="6389809" cy="137217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6:  Comparison of bispecific antibody vs. combination of monoclonal antibodies</a:t>
            </a:r>
            <a:endParaRPr lang="en-US" sz="1100" b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bronectin immunostaining was evaluated for CAFs subjected to antibody treatment for 72 hours.  Cells were treated as indicated with 10 μg/mL of IgG isotype control, each monospecific mAb (anti-αvβ3 or anti-α5β1), or the bispecific antibody recognizing αvβ3/α5β1 (BsAb).  The combination of monospecific mAbs was tested using 5 μg/mL of each mAb (“5+5”, for a total of 10 μg/mL) or 10 μg/mL of each mAb (“10+10”, for a total of 20 μg/ml).   </a:t>
            </a:r>
            <a:endParaRPr lang="en-US" sz="1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563071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2543e7ec-7072-4b75-829f-0ed03e19ff1e">
      <Terms xmlns="http://schemas.microsoft.com/office/infopath/2007/PartnerControls"/>
    </lcf76f155ced4ddcb4097134ff3c332f>
    <TaxCatchAll xmlns="57a0c4cc-3c09-49e8-920e-d8be8823b2ff" xsi:nil="true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2F3B51C6BCD074793790340586B5297" ma:contentTypeVersion="18" ma:contentTypeDescription="Create a new document." ma:contentTypeScope="" ma:versionID="d8e7e0b6111b9d67775a07373b940835">
  <xsd:schema xmlns:xsd="http://www.w3.org/2001/XMLSchema" xmlns:xs="http://www.w3.org/2001/XMLSchema" xmlns:p="http://schemas.microsoft.com/office/2006/metadata/properties" xmlns:ns2="57a0c4cc-3c09-49e8-920e-d8be8823b2ff" xmlns:ns3="2543e7ec-7072-4b75-829f-0ed03e19ff1e" targetNamespace="http://schemas.microsoft.com/office/2006/metadata/properties" ma:root="true" ma:fieldsID="26eab72f2527c02910f532a8625ffb45" ns2:_="" ns3:_="">
    <xsd:import namespace="57a0c4cc-3c09-49e8-920e-d8be8823b2ff"/>
    <xsd:import namespace="2543e7ec-7072-4b75-829f-0ed03e19ff1e"/>
    <xsd:element name="properties">
      <xsd:complexType>
        <xsd:sequence>
          <xsd:element name="documentManagement">
            <xsd:complexType>
              <xsd:all>
                <xsd:element ref="ns2:SharedWithUsers" minOccurs="0"/>
                <xsd:element ref="ns2:SharedWithDetails" minOccurs="0"/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3:MediaLengthInSeconds" minOccurs="0"/>
                <xsd:element ref="ns3:MediaServiceLocation" minOccurs="0"/>
                <xsd:element ref="ns3:lcf76f155ced4ddcb4097134ff3c332f" minOccurs="0"/>
                <xsd:element ref="ns2:TaxCatchAll" minOccurs="0"/>
                <xsd:element ref="ns3:MediaServiceObjectDetectorVersion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7a0c4cc-3c09-49e8-920e-d8be8823b2ff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3" nillable="true" ma:displayName="Taxonomy Catch All Column" ma:hidden="true" ma:list="{bfe539f8-3b21-43ac-9575-bd53185d5a89}" ma:internalName="TaxCatchAll" ma:showField="CatchAllData" ma:web="57a0c4cc-3c09-49e8-920e-d8be8823b2ff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543e7ec-7072-4b75-829f-0ed03e19ff1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0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1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7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8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19" nillable="true" ma:displayName="MediaLengthInSeconds" ma:hidden="true" ma:internalName="MediaLengthInSeconds" ma:readOnly="true">
      <xsd:simpleType>
        <xsd:restriction base="dms:Unknown"/>
      </xsd:simpleType>
    </xsd:element>
    <xsd:element name="MediaServiceLocation" ma:index="20" nillable="true" ma:displayName="Location" ma:internalName="MediaServiceLocation" ma:readOnly="true">
      <xsd:simpleType>
        <xsd:restriction base="dms:Text"/>
      </xsd:simpleType>
    </xsd:element>
    <xsd:element name="lcf76f155ced4ddcb4097134ff3c332f" ma:index="22" nillable="true" ma:taxonomy="true" ma:internalName="lcf76f155ced4ddcb4097134ff3c332f" ma:taxonomyFieldName="MediaServiceImageTags" ma:displayName="Image Tags" ma:readOnly="false" ma:fieldId="{5cf76f15-5ced-4ddc-b409-7134ff3c332f}" ma:taxonomyMulti="true" ma:sspId="2ccd466c-82b6-42a3-8ba5-5c7db83406b1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24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428AF018-5240-4F2F-B0A7-10A84DD9D260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08778B21-93DC-4DE6-9C7D-29A88DF3DBC8}">
  <ds:schemaRefs>
    <ds:schemaRef ds:uri="http://schemas.microsoft.com/office/2006/metadata/properties"/>
    <ds:schemaRef ds:uri="http://purl.org/dc/terms/"/>
    <ds:schemaRef ds:uri="http://schemas.microsoft.com/office/2006/documentManagement/types"/>
    <ds:schemaRef ds:uri="http://purl.org/dc/dcmitype/"/>
    <ds:schemaRef ds:uri="57a0c4cc-3c09-49e8-920e-d8be8823b2ff"/>
    <ds:schemaRef ds:uri="http://purl.org/dc/elements/1.1/"/>
    <ds:schemaRef ds:uri="http://schemas.microsoft.com/office/infopath/2007/PartnerControls"/>
    <ds:schemaRef ds:uri="http://schemas.openxmlformats.org/package/2006/metadata/core-properties"/>
    <ds:schemaRef ds:uri="2543e7ec-7072-4b75-829f-0ed03e19ff1e"/>
    <ds:schemaRef ds:uri="http://www.w3.org/XML/1998/namespace"/>
  </ds:schemaRefs>
</ds:datastoreItem>
</file>

<file path=customXml/itemProps3.xml><?xml version="1.0" encoding="utf-8"?>
<ds:datastoreItem xmlns:ds="http://schemas.openxmlformats.org/officeDocument/2006/customXml" ds:itemID="{B01E279D-CEC9-47C5-B8DD-CF8E61B016A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57a0c4cc-3c09-49e8-920e-d8be8823b2ff"/>
    <ds:schemaRef ds:uri="2543e7ec-7072-4b75-829f-0ed03e19ff1e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51</TotalTime>
  <Words>156</Words>
  <Application>Microsoft Office PowerPoint</Application>
  <PresentationFormat>A4 Paper (210x297 mm)</PresentationFormat>
  <Paragraphs>1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u, Chengsheng</dc:creator>
  <cp:lastModifiedBy>Weis, Sara</cp:lastModifiedBy>
  <cp:revision>20</cp:revision>
  <dcterms:created xsi:type="dcterms:W3CDTF">2024-03-19T17:07:22Z</dcterms:created>
  <dcterms:modified xsi:type="dcterms:W3CDTF">2025-01-02T17:23:2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2F3B51C6BCD074793790340586B5297</vt:lpwstr>
  </property>
  <property fmtid="{D5CDD505-2E9C-101B-9397-08002B2CF9AE}" pid="3" name="MediaServiceImageTags">
    <vt:lpwstr/>
  </property>
</Properties>
</file>